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400800" cy="6400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9470"/>
    <p:restoredTop sz="95775"/>
  </p:normalViewPr>
  <p:slideViewPr>
    <p:cSldViewPr snapToGrid="0" snapToObjects="1">
      <p:cViewPr varScale="1">
        <p:scale>
          <a:sx n="118" d="100"/>
          <a:sy n="118" d="100"/>
        </p:scale>
        <p:origin x="119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047539"/>
            <a:ext cx="5440680" cy="2228427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3361902"/>
            <a:ext cx="4800600" cy="1545378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933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180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340783"/>
            <a:ext cx="1380173" cy="54243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340783"/>
            <a:ext cx="4060508" cy="54243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360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887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1595757"/>
            <a:ext cx="5520690" cy="2662555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4283500"/>
            <a:ext cx="5520690" cy="1400175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289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1703917"/>
            <a:ext cx="2720340" cy="406124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1703917"/>
            <a:ext cx="2720340" cy="406124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705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340785"/>
            <a:ext cx="5520690" cy="123719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1569085"/>
            <a:ext cx="2707838" cy="768985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2338070"/>
            <a:ext cx="2707838" cy="343894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1569085"/>
            <a:ext cx="2721174" cy="768985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2338070"/>
            <a:ext cx="2721174" cy="343894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552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3070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218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26720"/>
            <a:ext cx="2064425" cy="149352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921598"/>
            <a:ext cx="3240405" cy="4548717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1920240"/>
            <a:ext cx="2064425" cy="3557482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800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26720"/>
            <a:ext cx="2064425" cy="149352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921598"/>
            <a:ext cx="3240405" cy="4548717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1920240"/>
            <a:ext cx="2064425" cy="3557482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836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340785"/>
            <a:ext cx="5520690" cy="12371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1703917"/>
            <a:ext cx="5520690" cy="40612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5932595"/>
            <a:ext cx="144018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58D10-2159-1742-924F-1B615E7E4945}" type="datetimeFigureOut">
              <a:rPr lang="en-US" smtClean="0"/>
              <a:t>9/2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5932595"/>
            <a:ext cx="216027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5932595"/>
            <a:ext cx="144018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1728E6-A669-E44A-87E2-49F01E3DB6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758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map&#10;&#10;Description automatically generated">
            <a:extLst>
              <a:ext uri="{FF2B5EF4-FFF2-40B4-BE49-F238E27FC236}">
                <a16:creationId xmlns:a16="http://schemas.microsoft.com/office/drawing/2014/main" id="{137DB331-F5FA-AC43-6EFA-1E8AF93126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4100" y="128444"/>
            <a:ext cx="5531757" cy="444282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D69D87D-E2AA-81AB-EB7E-44AFDB389DA9}"/>
              </a:ext>
            </a:extLst>
          </p:cNvPr>
          <p:cNvSpPr txBox="1"/>
          <p:nvPr/>
        </p:nvSpPr>
        <p:spPr>
          <a:xfrm>
            <a:off x="314100" y="4571272"/>
            <a:ext cx="5531757" cy="842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upplementary Figure 1: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Cluster level mutation presence. Colored dot indicates presence of mutation in a cluster, not prevalence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0641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2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 Kirby</dc:creator>
  <cp:lastModifiedBy>Rebecca Kirby</cp:lastModifiedBy>
  <cp:revision>1</cp:revision>
  <dcterms:created xsi:type="dcterms:W3CDTF">2022-09-28T15:37:04Z</dcterms:created>
  <dcterms:modified xsi:type="dcterms:W3CDTF">2022-09-28T15:44:12Z</dcterms:modified>
</cp:coreProperties>
</file>